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84" r:id="rId3"/>
  </p:sldIdLst>
  <p:sldSz cx="6858000" cy="9144000" type="letter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yse" initials="M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7DDA"/>
    <a:srgbClr val="FF9953"/>
    <a:srgbClr val="04481B"/>
    <a:srgbClr val="056726"/>
    <a:srgbClr val="079D39"/>
    <a:srgbClr val="00FF00"/>
    <a:srgbClr val="FF6600"/>
    <a:srgbClr val="CC3300"/>
    <a:srgbClr val="F9D6B9"/>
    <a:srgbClr val="F38E07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1219200" y="838200"/>
          <a:ext cx="4724401" cy="1295400"/>
        </p:xfrm>
        <a:graphic>
          <a:graphicData uri="http://schemas.openxmlformats.org/drawingml/2006/table">
            <a:tbl>
              <a:tblPr/>
              <a:tblGrid>
                <a:gridCol w="928692"/>
                <a:gridCol w="517293"/>
                <a:gridCol w="517900"/>
                <a:gridCol w="603711"/>
                <a:gridCol w="776547"/>
                <a:gridCol w="776547"/>
                <a:gridCol w="603711"/>
              </a:tblGrid>
              <a:tr h="38124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Residue no.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469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17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Asp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Asp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2859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224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89560" algn="l"/>
                          <a:tab pos="336550" algn="ctr"/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	</a:t>
                      </a:r>
                      <a:r>
                        <a:rPr lang="en-CA" sz="1100" b="0" cap="none" baseline="0" dirty="0" smtClean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6824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22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1143000" y="609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Tableau 11"/>
          <p:cNvGraphicFramePr>
            <a:graphicFrameLocks noGrp="1"/>
          </p:cNvGraphicFramePr>
          <p:nvPr/>
        </p:nvGraphicFramePr>
        <p:xfrm>
          <a:off x="1219200" y="2674944"/>
          <a:ext cx="4724401" cy="914400"/>
        </p:xfrm>
        <a:graphic>
          <a:graphicData uri="http://schemas.openxmlformats.org/drawingml/2006/table">
            <a:tbl>
              <a:tblPr/>
              <a:tblGrid>
                <a:gridCol w="928692"/>
                <a:gridCol w="517293"/>
                <a:gridCol w="517900"/>
                <a:gridCol w="603711"/>
                <a:gridCol w="776547"/>
                <a:gridCol w="776547"/>
                <a:gridCol w="603711"/>
              </a:tblGrid>
              <a:tr h="33892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Residue no.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*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0672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187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230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3" name="Tableau 12"/>
          <p:cNvGraphicFramePr>
            <a:graphicFrameLocks noGrp="1"/>
          </p:cNvGraphicFramePr>
          <p:nvPr/>
        </p:nvGraphicFramePr>
        <p:xfrm>
          <a:off x="1219200" y="4038600"/>
          <a:ext cx="4724401" cy="914400"/>
        </p:xfrm>
        <a:graphic>
          <a:graphicData uri="http://schemas.openxmlformats.org/drawingml/2006/table">
            <a:tbl>
              <a:tblPr/>
              <a:tblGrid>
                <a:gridCol w="928692"/>
                <a:gridCol w="517292"/>
                <a:gridCol w="517901"/>
                <a:gridCol w="603711"/>
                <a:gridCol w="776547"/>
                <a:gridCol w="776547"/>
                <a:gridCol w="603711"/>
              </a:tblGrid>
              <a:tr h="338928">
                <a:tc>
                  <a:txBody>
                    <a:bodyPr/>
                    <a:lstStyle/>
                    <a:p>
                      <a:pPr>
                        <a:spcAft>
                          <a:spcPts val="1000"/>
                        </a:spcAft>
                      </a:pPr>
                      <a:endParaRPr lang="en-CA" sz="1100" b="0" cap="all" dirty="0">
                        <a:latin typeface="Times New Roman"/>
                        <a:ea typeface="Cambria"/>
                        <a:cs typeface="Times New Roman"/>
                      </a:endParaRPr>
                    </a:p>
                  </a:txBody>
                  <a:tcPr marL="63549" marR="63549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72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K</a:t>
                      </a:r>
                      <a:r>
                        <a:rPr lang="en-CA" sz="1100" b="0" cap="all" baseline="-25000" dirty="0">
                          <a:latin typeface="Times New Roman"/>
                          <a:ea typeface="Cambria"/>
                          <a:cs typeface="Times New Roman"/>
                        </a:rPr>
                        <a:t>D</a:t>
                      </a: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 (µM)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0.080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-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68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16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 smtClean="0">
                          <a:latin typeface="Times New Roman"/>
                          <a:ea typeface="Cambria"/>
                          <a:cs typeface="Times New Roman"/>
                        </a:rPr>
                        <a:t>1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smtClean="0">
                          <a:latin typeface="Times New Roman"/>
                          <a:ea typeface="Cambria"/>
                          <a:cs typeface="Times New Roman"/>
                        </a:rPr>
                        <a:t>22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44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Binding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s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s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4" name="ZoneTexte 13"/>
          <p:cNvSpPr txBox="1"/>
          <p:nvPr/>
        </p:nvSpPr>
        <p:spPr>
          <a:xfrm>
            <a:off x="1143000" y="2313801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143000" y="3837801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228600" y="2286000"/>
          <a:ext cx="6324601" cy="4724404"/>
        </p:xfrm>
        <a:graphic>
          <a:graphicData uri="http://schemas.openxmlformats.org/drawingml/2006/table">
            <a:tbl>
              <a:tblPr/>
              <a:tblGrid>
                <a:gridCol w="560320"/>
                <a:gridCol w="2792480"/>
                <a:gridCol w="1208210"/>
                <a:gridCol w="1763591"/>
              </a:tblGrid>
              <a:tr h="18428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Nam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Sequenc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Used</a:t>
                      </a:r>
                      <a:r>
                        <a:rPr lang="en-US" sz="1100" b="1" cap="none" baseline="0" dirty="0" smtClean="0">
                          <a:latin typeface="Courier"/>
                          <a:ea typeface="Cambria"/>
                          <a:cs typeface="Times New Roman"/>
                        </a:rPr>
                        <a:t> for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100" b="1" cap="none" dirty="0" err="1" smtClean="0">
                          <a:latin typeface="Courier"/>
                          <a:ea typeface="Cambria"/>
                          <a:cs typeface="Times New Roman"/>
                        </a:rPr>
                        <a:t>Cloned</a:t>
                      </a:r>
                      <a:r>
                        <a:rPr lang="fr-FR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 in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754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TAGCTGTTTTACAACTGCAATGTCTCCTCCACA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5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  <a:endParaRPr lang="fr-FR" sz="1000" b="0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TGTGGAGGAGACATTGCAGTTGTAAAACAGCTA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ACTAGAATGTCTGCTCCACAACAAATA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TATTTGTTGTGGAGCAGACATTCTAGT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TATAGGTGCAGGAGCAGTAGCTAGCTGTTTT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9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AAAACAGCTAGCTACTGCTCCTGCACCTA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0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CCAGTAGCTAGCTGTGCTACAACTAGAATGTC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1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GACATTCTAGTTGTAGCACAGCTAGCTACTGG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CGGCGGATTCGCAGCTCCCCCTACTGAAC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i="1" cap="none" dirty="0">
                          <a:latin typeface="Courier"/>
                          <a:ea typeface="Calibri"/>
                          <a:cs typeface="Times New Roman"/>
                        </a:rPr>
                        <a:t>Pf</a:t>
                      </a: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TTCAGTAGGGGGAGCTGCGAATCCGCCG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4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AGACATGCAGGAGCTATGATTCCAGATA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TATCTGGAATCATAGCTCCTGCATGTCT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GCAGGAAACATGGCCCCAGACAACGATAA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TTATCGTTGTCTGGGGCCATGTTTCCTGC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2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ATAAGAACTCCAACGCCAAGTATCCCGCCG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3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CGGCGGGATACTTGGCGTTGGAGTTCT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53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AATGTCACATCCTGGCTATTGCCGCTCAGGAA 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536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TTCCTGAGCGGCAATAGCCAGGATGTGACATT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381000" y="228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able S3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2</TotalTime>
  <Words>186</Words>
  <Application>Microsoft Office PowerPoint</Application>
  <PresentationFormat>Format US (216 x 279 mm)</PresentationFormat>
  <Paragraphs>149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Office Theme</vt:lpstr>
      <vt:lpstr>Diapositive 1</vt:lpstr>
      <vt:lpstr>Diapositive 2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elle</dc:creator>
  <cp:lastModifiedBy>Maryse</cp:lastModifiedBy>
  <cp:revision>433</cp:revision>
  <cp:lastPrinted>2011-06-14T08:21:48Z</cp:lastPrinted>
  <dcterms:created xsi:type="dcterms:W3CDTF">2011-06-14T08:21:34Z</dcterms:created>
  <dcterms:modified xsi:type="dcterms:W3CDTF">2012-05-10T12:24:07Z</dcterms:modified>
</cp:coreProperties>
</file>